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9" r:id="rId3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3471" autoAdjust="0"/>
  </p:normalViewPr>
  <p:slideViewPr>
    <p:cSldViewPr snapToGrid="0">
      <p:cViewPr varScale="1">
        <p:scale>
          <a:sx n="95" d="100"/>
          <a:sy n="95" d="100"/>
        </p:scale>
        <p:origin x="11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D86AA9-A903-41EC-80E9-F5BE2586F4E9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C855C-16D2-4CCD-B25B-4CDABA755AB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47821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dirty="0" err="1"/>
              <a:t>Table</a:t>
            </a:r>
            <a:r>
              <a:rPr lang="hu-HU" dirty="0"/>
              <a:t> 1. </a:t>
            </a:r>
            <a:r>
              <a:rPr lang="en-US" dirty="0"/>
              <a:t>Potential </a:t>
            </a:r>
            <a:r>
              <a:rPr lang="hu-HU" dirty="0" err="1"/>
              <a:t>factor</a:t>
            </a:r>
            <a:r>
              <a:rPr lang="en-US" dirty="0"/>
              <a:t>s affecting PCSK9 levels in patients with CKD</a:t>
            </a:r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hu-HU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 HOMA-IR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meostasis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del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sessment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ulin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istance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; ** ESRD=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d-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g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nal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r>
              <a:rPr lang="hu-HU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; *** 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CVD =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erosclerotic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rdiovascular</a:t>
            </a:r>
            <a:r>
              <a:rPr lang="hu-HU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hu-HU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ease</a:t>
            </a:r>
            <a:endParaRPr lang="hu-H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lang="hu-HU" sz="120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0C855C-16D2-4CCD-B25B-4CDABA755AB0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07249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hu-HU" dirty="0" err="1"/>
              <a:t>Table</a:t>
            </a:r>
            <a:r>
              <a:rPr lang="hu-HU" dirty="0"/>
              <a:t> 2. E</a:t>
            </a:r>
            <a:r>
              <a:rPr lang="en-US" dirty="0" err="1"/>
              <a:t>fficacy</a:t>
            </a:r>
            <a:r>
              <a:rPr lang="en-US" dirty="0"/>
              <a:t> and safety of PCSK9 therapy in patients with CKD</a:t>
            </a:r>
            <a:endParaRPr lang="hu-HU" dirty="0"/>
          </a:p>
          <a:p>
            <a:r>
              <a:rPr lang="hu-HU" dirty="0" err="1"/>
              <a:t>yrs</a:t>
            </a:r>
            <a:r>
              <a:rPr lang="hu-HU" dirty="0"/>
              <a:t>*= </a:t>
            </a:r>
            <a:r>
              <a:rPr lang="hu-HU" dirty="0" err="1"/>
              <a:t>years</a:t>
            </a:r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B8FEF9-A188-4411-B7FE-8D8CCDF3658E}" type="slidenum">
              <a:rPr lang="hu-HU" smtClean="0"/>
              <a:t>2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95336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DA7856B-D781-4507-9C3D-E0BA73F027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A63C9336-389E-4476-A646-C67F80BCD7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F633583-C95E-4248-86EE-75A469692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B4B58EB-F17E-43C3-B31F-5E16EDD40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4F21FD2-4570-4DF4-BD76-EDDA527DE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415944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AE88CE8-ECBB-4B76-9078-ECA29837D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C9B1B6C0-A76D-4803-BF51-21EFCDB7E1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1AE6D46-987B-4EF3-92C8-54F384D0E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BC2CF62-D1A0-46AF-AEA9-0E875D078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75F8CE1-F49C-4757-B12D-435AE2613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34983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BC3D8611-B587-4C3F-B089-FAC9EC1469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F4023FF7-6B2F-4B48-A32D-D68672A9BB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041FA0A-C3A8-47E0-B3F6-67D7FF237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17839F8-25CC-4651-ABCF-566474CBE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92D1A50-A893-4449-BD5A-479B9976E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51963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E48DDCB-11F6-4B22-87CB-6D0C2497C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5233F0D0-EC7F-4C39-AB2E-0E0711A58A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8627CF5-8CC9-4548-9D7E-1F0C5FEB2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2712A7A-9AFD-43DA-951D-2C0029218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2A6864C-AC79-4986-848E-4A56FBD6B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24207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37B543D-D8CD-43C1-96DD-B67E6D8C5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319D733-4A70-4344-B6E6-24F0AEDF84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D6F578D-F091-469F-AC44-64E5C453C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D5C7129-6147-4B9B-970F-A4AF4C27C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B0C4545-9452-452D-8B69-5892A4DA72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93786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1216078-94C2-455E-A88B-8478E432D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EB700FE0-B8BD-4A87-AC54-65211F1801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47D99640-4422-4EA5-9C8E-E9353A39D3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85F7331-FEC4-4C19-848B-704121052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4CCCD356-339F-4C0C-8729-136BCBBB1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C8443807-40E0-4725-BBB5-08A952D70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28528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AEEFC40-147A-4D6B-85AA-5907FE8AB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3193CD6-6E41-49F7-81CC-4009B25DF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471A6ACF-B452-4651-AEB3-9E575B830F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BF65EB34-A1B1-4565-9888-6B6E39829C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AFA63875-7B15-4A9C-BABC-0232A0DF12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F84FBF47-09EE-420B-B582-1397A355D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C4615A0E-2B7A-43CA-B6D5-FA7224677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AE0474DF-9F17-44C4-B1CC-59605E282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99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1860740-1DC8-45D8-A46C-9626A62FF4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57310897-B860-4682-8B5D-37164600A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5B662562-F675-455C-92C2-46129DF35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33BE7C85-14B6-4FC8-A54E-39495992F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07101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5CB6CC78-72D9-4B0A-8FD2-1F159F0D2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3DC22632-36FE-4E0B-960A-F9BD283FE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AF6B91FA-4011-42F9-B3AE-E93035E63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9979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E742E1E-6C37-40DF-81CF-4DEC05865D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99D69F13-2411-40BF-BD05-78624184F7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4ED9AB57-AA66-426A-8BBD-AFCCE926D8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5BE94C50-EA80-4162-9B11-7A4AAD486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109C239C-8B7C-4F36-8E62-7FFC91FF4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7C25A0BB-61CA-4231-BCBC-F131EF443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56889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F5D5DA6-5E44-4400-BDB2-00C59089A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BA3F3F07-4B2F-42A3-A4C1-27E21431FD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AA3EAB3D-0A0C-4F88-8866-3D75F227FA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3C0E86B-4695-4A90-992C-12C6B1352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578B1C6F-546E-4BB1-A3D2-8AAF98E6D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DF74E7B-902E-4500-8249-3411FAE64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37540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7B099ECC-CA0A-47BB-B717-1C98070AE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91375E1A-3CA7-4B37-9C6D-9812FEBA91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9A68A57-FF94-43DA-927C-C07313A351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8BA06-58FD-4AC5-AF43-673FDB790996}" type="datetimeFigureOut">
              <a:rPr lang="hu-HU" smtClean="0"/>
              <a:t>2025. 05. 17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41C12EF-6A15-42BE-9802-AAF44574DB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12B7928-7C66-48E5-A4AE-130E25198E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F5757-A26F-4687-8575-B72E61162169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00450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áblázat 1">
            <a:extLst>
              <a:ext uri="{FF2B5EF4-FFF2-40B4-BE49-F238E27FC236}">
                <a16:creationId xmlns:a16="http://schemas.microsoft.com/office/drawing/2014/main" id="{7154CBFB-630A-4CA8-8A4F-EF05794AD6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1750515"/>
              </p:ext>
            </p:extLst>
          </p:nvPr>
        </p:nvGraphicFramePr>
        <p:xfrm>
          <a:off x="522514" y="391887"/>
          <a:ext cx="11163719" cy="603905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40945">
                  <a:extLst>
                    <a:ext uri="{9D8B030D-6E8A-4147-A177-3AD203B41FA5}">
                      <a16:colId xmlns:a16="http://schemas.microsoft.com/office/drawing/2014/main" val="3274591707"/>
                    </a:ext>
                  </a:extLst>
                </a:gridCol>
                <a:gridCol w="5622774">
                  <a:extLst>
                    <a:ext uri="{9D8B030D-6E8A-4147-A177-3AD203B41FA5}">
                      <a16:colId xmlns:a16="http://schemas.microsoft.com/office/drawing/2014/main" val="3360602684"/>
                    </a:ext>
                  </a:extLst>
                </a:gridCol>
              </a:tblGrid>
              <a:tr h="606634"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FACTO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REFERENC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9848625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Fast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glucose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insulin</a:t>
                      </a:r>
                      <a:r>
                        <a:rPr lang="hu-HU" dirty="0"/>
                        <a:t>, HOMA-IR*, HbA1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uscica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</a:t>
                      </a:r>
                      <a:r>
                        <a:rPr lang="hu-HU" dirty="0"/>
                        <a:t>(61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cchi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</a:t>
                      </a:r>
                      <a:r>
                        <a:rPr lang="hu-HU" dirty="0"/>
                        <a:t>(62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010603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Circadia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rhythm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fasting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te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bujra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60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954857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 err="1"/>
                        <a:t>Proteinuria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Ji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68); </a:t>
                      </a:r>
                      <a:r>
                        <a:rPr lang="hu-HU" dirty="0" err="1"/>
                        <a:t>Dorio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7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6656099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dirty="0"/>
                        <a:t>ESRD** (</a:t>
                      </a:r>
                      <a:r>
                        <a:rPr lang="hu-HU" dirty="0" err="1"/>
                        <a:t>treated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peritoneal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dialysis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or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emodialysis</a:t>
                      </a:r>
                      <a:r>
                        <a:rPr lang="hu-HU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dirty="0" err="1"/>
                        <a:t>Jin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68); Rasmussen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. (77)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8776590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pid-lowering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eatment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ati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zetimibe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ati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ibrate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bination</a:t>
                      </a:r>
                      <a:r>
                        <a:rPr lang="hu-HU" sz="180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hu-HU" i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ogacev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56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ubuc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82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lewa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89) 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0867988"/>
                  </a:ext>
                </a:extLst>
              </a:tr>
              <a:tr h="9054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SCVD***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heirkhah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58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la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2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rålberg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3);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ajingulu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04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8151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7311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áblázat 2">
            <a:extLst>
              <a:ext uri="{FF2B5EF4-FFF2-40B4-BE49-F238E27FC236}">
                <a16:creationId xmlns:a16="http://schemas.microsoft.com/office/drawing/2014/main" id="{2B8EC4D2-7B7F-422B-8D1C-050610A230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7265252"/>
              </p:ext>
            </p:extLst>
          </p:nvPr>
        </p:nvGraphicFramePr>
        <p:xfrm>
          <a:off x="110532" y="44579"/>
          <a:ext cx="11995218" cy="67079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68914">
                  <a:extLst>
                    <a:ext uri="{9D8B030D-6E8A-4147-A177-3AD203B41FA5}">
                      <a16:colId xmlns:a16="http://schemas.microsoft.com/office/drawing/2014/main" val="4258576095"/>
                    </a:ext>
                  </a:extLst>
                </a:gridCol>
                <a:gridCol w="3770217">
                  <a:extLst>
                    <a:ext uri="{9D8B030D-6E8A-4147-A177-3AD203B41FA5}">
                      <a16:colId xmlns:a16="http://schemas.microsoft.com/office/drawing/2014/main" val="915764734"/>
                    </a:ext>
                  </a:extLst>
                </a:gridCol>
                <a:gridCol w="2665567">
                  <a:extLst>
                    <a:ext uri="{9D8B030D-6E8A-4147-A177-3AD203B41FA5}">
                      <a16:colId xmlns:a16="http://schemas.microsoft.com/office/drawing/2014/main" val="1815266029"/>
                    </a:ext>
                  </a:extLst>
                </a:gridCol>
                <a:gridCol w="2790520">
                  <a:extLst>
                    <a:ext uri="{9D8B030D-6E8A-4147-A177-3AD203B41FA5}">
                      <a16:colId xmlns:a16="http://schemas.microsoft.com/office/drawing/2014/main" val="1068827842"/>
                    </a:ext>
                  </a:extLst>
                </a:gridCol>
              </a:tblGrid>
              <a:tr h="788474"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Efficacy</a:t>
                      </a:r>
                      <a:r>
                        <a:rPr lang="hu-HU" dirty="0"/>
                        <a:t> and </a:t>
                      </a:r>
                      <a:r>
                        <a:rPr lang="hu-HU" dirty="0" err="1"/>
                        <a:t>safety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Patient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/>
                        <a:t>PCSK9 </a:t>
                      </a:r>
                      <a:r>
                        <a:rPr lang="hu-HU" dirty="0" err="1"/>
                        <a:t>inhibitors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Intervention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dirty="0" err="1"/>
                        <a:t>References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6572003"/>
                  </a:ext>
                </a:extLst>
              </a:tr>
              <a:tr h="89730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N</a:t>
                      </a:r>
                      <a:r>
                        <a:rPr lang="en-US" dirty="0" err="1"/>
                        <a:t>ot</a:t>
                      </a:r>
                      <a:r>
                        <a:rPr lang="en-US" dirty="0"/>
                        <a:t> increase the rate </a:t>
                      </a:r>
                      <a:r>
                        <a:rPr lang="hu-HU" dirty="0"/>
                        <a:t>of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w-ons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iabete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dirty="0"/>
                        <a:t>15.034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2 CKD</a:t>
                      </a:r>
                    </a:p>
                    <a:p>
                      <a:pPr algn="l"/>
                      <a:r>
                        <a:rPr lang="hu-HU" dirty="0"/>
                        <a:t>and 4.443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u="sng" dirty="0"/>
                        <a:t>&gt;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3 CK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dirty="0" err="1"/>
                        <a:t>Evolocumab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aryta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1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3355240"/>
                  </a:ext>
                </a:extLst>
              </a:tr>
              <a:tr h="186659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N</a:t>
                      </a:r>
                      <a:r>
                        <a:rPr lang="en-US" dirty="0" err="1"/>
                        <a:t>ot</a:t>
                      </a:r>
                      <a:r>
                        <a:rPr lang="en-US" dirty="0"/>
                        <a:t> </a:t>
                      </a:r>
                      <a:r>
                        <a:rPr lang="hu-HU" dirty="0" err="1"/>
                        <a:t>change</a:t>
                      </a:r>
                      <a:r>
                        <a:rPr lang="en-US" dirty="0"/>
                        <a:t> proteinuria</a:t>
                      </a: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hu-HU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ignificantly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creased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teinuria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20 </a:t>
                      </a:r>
                      <a:r>
                        <a:rPr lang="hu-HU" dirty="0" err="1"/>
                        <a:t>primar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nephrotic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yndrome</a:t>
                      </a:r>
                      <a:r>
                        <a:rPr lang="hu-HU" dirty="0"/>
                        <a:t>,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0-3 CKD, </a:t>
                      </a:r>
                    </a:p>
                    <a:p>
                      <a:endParaRPr lang="hu-HU" dirty="0"/>
                    </a:p>
                    <a:p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76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CKD,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1 </a:t>
                      </a:r>
                      <a:r>
                        <a:rPr lang="hu-HU" dirty="0" err="1"/>
                        <a:t>to</a:t>
                      </a:r>
                      <a:r>
                        <a:rPr lang="hu-HU" dirty="0"/>
                        <a:t> 4 CK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irocumab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olocumab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hu-HU" dirty="0"/>
                    </a:p>
                    <a:p>
                      <a:endParaRPr lang="hu-HU" dirty="0"/>
                    </a:p>
                    <a:p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PCSK9 </a:t>
                      </a:r>
                      <a:r>
                        <a:rPr lang="hu-HU" dirty="0" err="1"/>
                        <a:t>inbibitors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Jatem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6)</a:t>
                      </a: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amo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7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1705451"/>
                  </a:ext>
                </a:extLst>
              </a:tr>
              <a:tr h="136257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In patients with ESRD</a:t>
                      </a:r>
                      <a:r>
                        <a:rPr lang="hu-HU" dirty="0"/>
                        <a:t> (</a:t>
                      </a:r>
                      <a:r>
                        <a:rPr lang="en-US" dirty="0"/>
                        <a:t>case reports</a:t>
                      </a:r>
                      <a:r>
                        <a:rPr lang="hu-HU" dirty="0"/>
                        <a:t>)</a:t>
                      </a:r>
                      <a:r>
                        <a:rPr lang="en-US" dirty="0"/>
                        <a:t> </a:t>
                      </a:r>
                      <a:r>
                        <a:rPr lang="hu-HU" dirty="0" err="1"/>
                        <a:t>the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have</a:t>
                      </a:r>
                      <a:r>
                        <a:rPr lang="hu-HU" dirty="0"/>
                        <a:t> </a:t>
                      </a:r>
                      <a:r>
                        <a:rPr lang="en-US" dirty="0"/>
                        <a:t>no side effects and help to achieve LDL-cholesterol targets 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/>
                        <a:t>68 </a:t>
                      </a:r>
                      <a:r>
                        <a:rPr lang="hu-HU" dirty="0" err="1"/>
                        <a:t>yrs</a:t>
                      </a:r>
                      <a:r>
                        <a:rPr lang="hu-HU" dirty="0"/>
                        <a:t>*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mo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1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and 65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mo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eritone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ialysis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9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yr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idney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ansplant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Evol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olocumab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clisiran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ousdampani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8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shii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9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anchidriá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20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Ueberdiek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21)</a:t>
                      </a:r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3003218"/>
                  </a:ext>
                </a:extLst>
              </a:tr>
              <a:tr h="17929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dirty="0"/>
                        <a:t>E</a:t>
                      </a:r>
                      <a:r>
                        <a:rPr lang="en-US" dirty="0" err="1"/>
                        <a:t>ffective</a:t>
                      </a:r>
                      <a:r>
                        <a:rPr lang="en-US" dirty="0"/>
                        <a:t> in improving the lipid profile</a:t>
                      </a:r>
                      <a:r>
                        <a:rPr lang="hu-HU" dirty="0"/>
                        <a:t>,</a:t>
                      </a:r>
                      <a:r>
                        <a:rPr lang="en-US" dirty="0"/>
                        <a:t> reducing the risk of ASCVD </a:t>
                      </a:r>
                      <a:r>
                        <a:rPr lang="hu-HU" dirty="0"/>
                        <a:t>(</a:t>
                      </a:r>
                      <a:r>
                        <a:rPr lang="hu-HU" dirty="0" err="1"/>
                        <a:t>mainly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for</a:t>
                      </a:r>
                      <a:r>
                        <a:rPr lang="hu-HU" dirty="0"/>
                        <a:t> </a:t>
                      </a:r>
                      <a:r>
                        <a:rPr lang="en-US" dirty="0"/>
                        <a:t>CKD &lt; 3 CKD stage</a:t>
                      </a:r>
                      <a:r>
                        <a:rPr lang="hu-HU" dirty="0"/>
                        <a:t>)</a:t>
                      </a:r>
                      <a:r>
                        <a:rPr lang="en-US" dirty="0"/>
                        <a:t> 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16 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60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hu-HU" sz="1800" kern="1200" baseline="300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20 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60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hu-HU" sz="18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67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GFR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u="non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-59 ml/min/1.73m</a:t>
                      </a:r>
                      <a:r>
                        <a:rPr lang="hu-HU" sz="18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</a:p>
                    <a:p>
                      <a:pPr marL="285750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hu-HU" dirty="0"/>
                        <a:t>15.034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2 CKD and 4.443 </a:t>
                      </a:r>
                      <a:r>
                        <a:rPr lang="hu-HU" dirty="0" err="1"/>
                        <a:t>with</a:t>
                      </a:r>
                      <a:r>
                        <a:rPr lang="hu-HU" dirty="0"/>
                        <a:t> </a:t>
                      </a:r>
                      <a:r>
                        <a:rPr lang="hu-HU" u="sng" dirty="0"/>
                        <a:t>&gt;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stage</a:t>
                      </a:r>
                      <a:r>
                        <a:rPr lang="hu-HU" dirty="0"/>
                        <a:t> 3 CKD</a:t>
                      </a:r>
                      <a:endParaRPr lang="hu-HU" sz="18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endParaRPr lang="hu-HU" sz="1800" kern="1200" baseline="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Alirocumab</a:t>
                      </a:r>
                      <a:endParaRPr lang="hu-HU" dirty="0"/>
                    </a:p>
                    <a:p>
                      <a:pPr marL="285750" indent="-285750">
                        <a:buFont typeface="Arial" panose="020B0604020202020204" pitchFamily="34" charset="0"/>
                        <a:buChar char="•"/>
                      </a:pPr>
                      <a:r>
                        <a:rPr lang="hu-HU" dirty="0" err="1"/>
                        <a:t>Evolocumab</a:t>
                      </a:r>
                      <a:endParaRPr lang="hu-H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ereiakes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123)</a:t>
                      </a:r>
                    </a:p>
                    <a:p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nno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124)</a:t>
                      </a:r>
                    </a:p>
                    <a:p>
                      <a:r>
                        <a:rPr lang="hu-HU" dirty="0" err="1"/>
                        <a:t>Toth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et</a:t>
                      </a:r>
                      <a:r>
                        <a:rPr lang="hu-HU" dirty="0"/>
                        <a:t> </a:t>
                      </a:r>
                      <a:r>
                        <a:rPr lang="hu-HU" dirty="0" err="1"/>
                        <a:t>al</a:t>
                      </a:r>
                      <a:r>
                        <a:rPr lang="hu-HU" dirty="0"/>
                        <a:t> (110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arytan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t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hu-HU" sz="18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</a:t>
                      </a:r>
                      <a:r>
                        <a:rPr lang="hu-HU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 (111)</a:t>
                      </a:r>
                      <a:endParaRPr lang="hu-HU" dirty="0"/>
                    </a:p>
                    <a:p>
                      <a:endParaRPr lang="hu-H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02690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4247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31</TotalTime>
  <Words>439</Words>
  <Application>Microsoft Office PowerPoint</Application>
  <PresentationFormat>Szélesvásznú</PresentationFormat>
  <Paragraphs>74</Paragraphs>
  <Slides>2</Slides>
  <Notes>2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-téma</vt:lpstr>
      <vt:lpstr>PowerPoint-bemutató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Dr. Ábel Tatjana Katalin (főiskolai docens)</dc:creator>
  <cp:lastModifiedBy>Dr. Ábel Tatjana Katalin (főiskolai docens)</cp:lastModifiedBy>
  <cp:revision>42</cp:revision>
  <dcterms:created xsi:type="dcterms:W3CDTF">2025-01-19T14:25:36Z</dcterms:created>
  <dcterms:modified xsi:type="dcterms:W3CDTF">2025-05-17T12:34:24Z</dcterms:modified>
</cp:coreProperties>
</file>